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0" r:id="rId2"/>
  </p:sldIdLst>
  <p:sldSz cx="6858000" cy="9902825"/>
  <p:notesSz cx="7099300" cy="10234613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Times" pitchFamily="18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Times" pitchFamily="18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Times" pitchFamily="18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Times" pitchFamily="18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Times" pitchFamily="18" charset="0"/>
        <a:ea typeface="+mn-ea"/>
        <a:cs typeface="Arial" charset="0"/>
      </a:defRPr>
    </a:lvl5pPr>
    <a:lvl6pPr marL="2286000" algn="l" defTabSz="914400" rtl="0" eaLnBrk="1" latinLnBrk="0" hangingPunct="1">
      <a:defRPr sz="2400" b="1" kern="1200">
        <a:solidFill>
          <a:schemeClr val="tx1"/>
        </a:solidFill>
        <a:latin typeface="Times" pitchFamily="18" charset="0"/>
        <a:ea typeface="+mn-ea"/>
        <a:cs typeface="Arial" charset="0"/>
      </a:defRPr>
    </a:lvl6pPr>
    <a:lvl7pPr marL="2743200" algn="l" defTabSz="914400" rtl="0" eaLnBrk="1" latinLnBrk="0" hangingPunct="1">
      <a:defRPr sz="2400" b="1" kern="1200">
        <a:solidFill>
          <a:schemeClr val="tx1"/>
        </a:solidFill>
        <a:latin typeface="Times" pitchFamily="18" charset="0"/>
        <a:ea typeface="+mn-ea"/>
        <a:cs typeface="Arial" charset="0"/>
      </a:defRPr>
    </a:lvl7pPr>
    <a:lvl8pPr marL="3200400" algn="l" defTabSz="914400" rtl="0" eaLnBrk="1" latinLnBrk="0" hangingPunct="1">
      <a:defRPr sz="2400" b="1" kern="1200">
        <a:solidFill>
          <a:schemeClr val="tx1"/>
        </a:solidFill>
        <a:latin typeface="Times" pitchFamily="18" charset="0"/>
        <a:ea typeface="+mn-ea"/>
        <a:cs typeface="Arial" charset="0"/>
      </a:defRPr>
    </a:lvl8pPr>
    <a:lvl9pPr marL="3657600" algn="l" defTabSz="914400" rtl="0" eaLnBrk="1" latinLnBrk="0" hangingPunct="1">
      <a:defRPr sz="2400" b="1" kern="1200">
        <a:solidFill>
          <a:schemeClr val="tx1"/>
        </a:solidFill>
        <a:latin typeface="Times" pitchFamily="18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00"/>
    <a:srgbClr val="C0C0C0"/>
    <a:srgbClr val="FFFF66"/>
    <a:srgbClr val="CBCBFF"/>
    <a:srgbClr val="000099"/>
    <a:srgbClr val="CC3300"/>
  </p:clrMru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中度样式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4521" autoAdjust="0"/>
    <p:restoredTop sz="98358" autoAdjust="0"/>
  </p:normalViewPr>
  <p:slideViewPr>
    <p:cSldViewPr snapToObjects="1">
      <p:cViewPr>
        <p:scale>
          <a:sx n="100" d="100"/>
          <a:sy n="100" d="100"/>
        </p:scale>
        <p:origin x="-1056" y="1470"/>
      </p:cViewPr>
      <p:guideLst>
        <p:guide orient="horz" pos="4508"/>
        <p:guide pos="4315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46085125" cy="4608512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39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77137" cy="5123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4768" tIns="47384" rIns="94768" bIns="47384" numCol="1" anchor="t" anchorCtr="0" compatLnSpc="1">
            <a:prstTxWarp prst="textNoShape">
              <a:avLst/>
            </a:prstTxWarp>
          </a:bodyPr>
          <a:lstStyle>
            <a:lvl1pPr algn="l" eaLnBrk="0" hangingPunct="0">
              <a:defRPr sz="1200" b="0">
                <a:effectLst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9395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4020506" y="0"/>
            <a:ext cx="3077137" cy="5123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4768" tIns="47384" rIns="94768" bIns="47384" numCol="1" anchor="t" anchorCtr="0" compatLnSpc="1">
            <a:prstTxWarp prst="textNoShape">
              <a:avLst/>
            </a:prstTxWarp>
          </a:bodyPr>
          <a:lstStyle>
            <a:lvl1pPr algn="r" eaLnBrk="0" hangingPunct="0">
              <a:defRPr sz="1200" b="0">
                <a:effectLst/>
                <a:cs typeface="+mn-cs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9396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720673"/>
            <a:ext cx="3077137" cy="5123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4768" tIns="47384" rIns="94768" bIns="47384" numCol="1" anchor="b" anchorCtr="0" compatLnSpc="1">
            <a:prstTxWarp prst="textNoShape">
              <a:avLst/>
            </a:prstTxWarp>
          </a:bodyPr>
          <a:lstStyle>
            <a:lvl1pPr algn="l" eaLnBrk="0" hangingPunct="0">
              <a:defRPr sz="1200" b="0">
                <a:effectLst/>
                <a:cs typeface="+mn-cs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9397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4020506" y="9720673"/>
            <a:ext cx="3077137" cy="5123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4768" tIns="47384" rIns="94768" bIns="47384" numCol="1" anchor="b" anchorCtr="0" compatLnSpc="1">
            <a:prstTxWarp prst="textNoShape">
              <a:avLst/>
            </a:prstTxWarp>
          </a:bodyPr>
          <a:lstStyle>
            <a:lvl1pPr algn="r" eaLnBrk="0" hangingPunct="0">
              <a:defRPr sz="1200" b="0">
                <a:effectLst/>
                <a:cs typeface="+mn-cs"/>
              </a:defRPr>
            </a:lvl1pPr>
          </a:lstStyle>
          <a:p>
            <a:pPr>
              <a:defRPr/>
            </a:pPr>
            <a:fld id="{4CCBA84C-5AD7-4942-9C0C-673C748C9239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7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75480" cy="5123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4768" tIns="47384" rIns="94768" bIns="47384" numCol="1" anchor="t" anchorCtr="0" compatLnSpc="1">
            <a:prstTxWarp prst="textNoShape">
              <a:avLst/>
            </a:prstTxWarp>
          </a:bodyPr>
          <a:lstStyle>
            <a:lvl1pPr algn="l" eaLnBrk="0" hangingPunct="0">
              <a:defRPr sz="1200" b="0">
                <a:effectLst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277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4022163" y="0"/>
            <a:ext cx="3075480" cy="5123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4768" tIns="47384" rIns="94768" bIns="47384" numCol="1" anchor="t" anchorCtr="0" compatLnSpc="1">
            <a:prstTxWarp prst="textNoShape">
              <a:avLst/>
            </a:prstTxWarp>
          </a:bodyPr>
          <a:lstStyle>
            <a:lvl1pPr algn="r" eaLnBrk="0" hangingPunct="0">
              <a:defRPr sz="1200" b="0">
                <a:effectLst/>
                <a:cs typeface="+mn-cs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0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22500" y="768350"/>
            <a:ext cx="2657475" cy="383698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277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709599" y="4861155"/>
            <a:ext cx="5680103" cy="46058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4768" tIns="47384" rIns="94768" bIns="4738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noProof="0" smtClean="0"/>
              <a:t>Click to edit Master text styles</a:t>
            </a:r>
          </a:p>
          <a:p>
            <a:pPr lvl="1"/>
            <a:r>
              <a:rPr lang="en-US" altLang="zh-CN" noProof="0" smtClean="0"/>
              <a:t>Second level</a:t>
            </a:r>
          </a:p>
          <a:p>
            <a:pPr lvl="2"/>
            <a:r>
              <a:rPr lang="en-US" altLang="zh-CN" noProof="0" smtClean="0"/>
              <a:t>Third level</a:t>
            </a:r>
          </a:p>
          <a:p>
            <a:pPr lvl="3"/>
            <a:r>
              <a:rPr lang="en-US" altLang="zh-CN" noProof="0" smtClean="0"/>
              <a:t>Fourth level</a:t>
            </a:r>
          </a:p>
          <a:p>
            <a:pPr lvl="4"/>
            <a:r>
              <a:rPr lang="en-US" altLang="zh-CN" noProof="0" smtClean="0"/>
              <a:t>Fifth level</a:t>
            </a:r>
          </a:p>
        </p:txBody>
      </p:sp>
      <p:sp>
        <p:nvSpPr>
          <p:cNvPr id="3277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720673"/>
            <a:ext cx="3075480" cy="5123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4768" tIns="47384" rIns="94768" bIns="47384" numCol="1" anchor="b" anchorCtr="0" compatLnSpc="1">
            <a:prstTxWarp prst="textNoShape">
              <a:avLst/>
            </a:prstTxWarp>
          </a:bodyPr>
          <a:lstStyle>
            <a:lvl1pPr algn="l" eaLnBrk="0" hangingPunct="0">
              <a:defRPr sz="1200" b="0">
                <a:effectLst/>
                <a:cs typeface="+mn-cs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277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4022163" y="9720673"/>
            <a:ext cx="3075480" cy="5123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4768" tIns="47384" rIns="94768" bIns="47384" numCol="1" anchor="b" anchorCtr="0" compatLnSpc="1">
            <a:prstTxWarp prst="textNoShape">
              <a:avLst/>
            </a:prstTxWarp>
          </a:bodyPr>
          <a:lstStyle>
            <a:lvl1pPr algn="r" eaLnBrk="0" hangingPunct="0">
              <a:defRPr sz="1200" b="0">
                <a:effectLst/>
                <a:cs typeface="+mn-cs"/>
              </a:defRPr>
            </a:lvl1pPr>
          </a:lstStyle>
          <a:p>
            <a:pPr>
              <a:defRPr/>
            </a:pPr>
            <a:fld id="{B0BC816B-CA26-4250-A45E-DACFAEAC9511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pitchFamily="18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pitchFamily="18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pitchFamily="18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pitchFamily="18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pitchFamily="18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6574"/>
            <a:ext cx="5829300" cy="2122488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1822"/>
            <a:ext cx="4800600" cy="2530475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77E8F9F-6997-480F-A5A8-A4C722449E9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101C1E-CC35-4F5A-B3F4-D00C7C9B193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886326" y="879477"/>
            <a:ext cx="1457325" cy="792321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514351" y="879477"/>
            <a:ext cx="4219575" cy="792321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981A1D-7B2C-4A24-956D-8BF75E6625B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FA8EC77-880E-4CC3-84F4-A03179B6213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6362701"/>
            <a:ext cx="5829300" cy="1966914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4197350"/>
            <a:ext cx="5829300" cy="21653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D3A9C55-7BA9-4348-8476-26AE6138A9E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514350" y="2860676"/>
            <a:ext cx="2838450" cy="594201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860676"/>
            <a:ext cx="2838450" cy="594201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EB9C8F5-B4E5-4107-8C69-0AEA1764A4C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876"/>
            <a:ext cx="6172200" cy="1649412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6151"/>
            <a:ext cx="3030538" cy="9239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0075"/>
            <a:ext cx="3030538" cy="570547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70" y="2216151"/>
            <a:ext cx="3030537" cy="9239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70" y="3140075"/>
            <a:ext cx="3030537" cy="570547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33A6EA-97E5-498B-AB1B-0CAB6DFE457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7AC3C4-61A6-4503-9EDA-4E460EFA043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892477E-9355-4F6A-840F-B9C7B41745D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798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3702"/>
            <a:ext cx="3833812" cy="84518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1689"/>
            <a:ext cx="2255838" cy="6773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58FC967-AF8D-4AB3-96B5-E816EB57A5B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932613"/>
            <a:ext cx="4114800" cy="81756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84238"/>
            <a:ext cx="4114800" cy="594201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750175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8C68197-442C-4288-B1E0-E3FF926D65E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79476"/>
            <a:ext cx="5829300" cy="1650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860676"/>
            <a:ext cx="5829300" cy="59420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1" y="9023351"/>
            <a:ext cx="1428750" cy="6588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 eaLnBrk="0" hangingPunct="0">
              <a:defRPr sz="1400" b="0">
                <a:effectLst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3351"/>
            <a:ext cx="2171700" cy="6588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0" hangingPunct="0">
              <a:defRPr sz="1400" b="0">
                <a:effectLst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3351"/>
            <a:ext cx="1428750" cy="6588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0" hangingPunct="0">
              <a:defRPr sz="1400" b="0">
                <a:effectLst/>
                <a:cs typeface="+mn-cs"/>
              </a:defRPr>
            </a:lvl1pPr>
          </a:lstStyle>
          <a:p>
            <a:pPr>
              <a:defRPr/>
            </a:pPr>
            <a:fld id="{50B99F16-B851-44BB-BB35-42D3122703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pitchFamily="18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pitchFamily="18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pitchFamily="18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pitchFamily="18" charset="0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pitchFamily="18" charset="0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pitchFamily="18" charset="0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pitchFamily="18" charset="0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pitchFamily="18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33632" y="707329"/>
            <a:ext cx="55306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Table S1</a:t>
            </a:r>
            <a:r>
              <a:rPr lang="zh-CN" altLang="en-US" sz="1200" dirty="0" smtClean="0">
                <a:latin typeface="Arial" pitchFamily="34" charset="0"/>
                <a:cs typeface="Arial" pitchFamily="34" charset="0"/>
              </a:rPr>
              <a:t>：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omparison of 17 cytokine/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chemokin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between HFMD patients at distinct clinical stages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" name="表格 2"/>
          <p:cNvGraphicFramePr>
            <a:graphicFrameLocks noGrp="1"/>
          </p:cNvGraphicFramePr>
          <p:nvPr/>
        </p:nvGraphicFramePr>
        <p:xfrm>
          <a:off x="458669" y="1261020"/>
          <a:ext cx="5805644" cy="7405107"/>
        </p:xfrm>
        <a:graphic>
          <a:graphicData uri="http://schemas.openxmlformats.org/drawingml/2006/table">
            <a:tbl>
              <a:tblPr/>
              <a:tblGrid>
                <a:gridCol w="535676"/>
                <a:gridCol w="773756"/>
                <a:gridCol w="972155"/>
                <a:gridCol w="902715"/>
                <a:gridCol w="902715"/>
                <a:gridCol w="111599"/>
                <a:gridCol w="535676"/>
                <a:gridCol w="535676"/>
                <a:gridCol w="535676"/>
              </a:tblGrid>
              <a:tr h="190682">
                <a:tc>
                  <a:txBody>
                    <a:bodyPr/>
                    <a:lstStyle/>
                    <a:p>
                      <a:pPr algn="l" fontAlgn="ctr"/>
                      <a:endParaRPr lang="zh-CN" altLang="en-US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VS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value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01275"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（n=8）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（n=23）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（n=19）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（n=10）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VS/H)    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S/H)    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M/H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M-CSF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30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49.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84.29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0.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02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106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17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1411.64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1626.40) 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473.96)     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129.72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IP-1</a:t>
                      </a:r>
                      <a:r>
                        <a:rPr lang="el-GR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4.56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76.72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6.15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3.56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108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218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106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62.76-561.21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56.04-440.29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41.16-143.61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11.02-168.48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L-2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1.19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6.66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71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.82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768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734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1136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55.90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128.91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15.55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10.73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L-3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1.31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32.8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1.52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5.89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065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84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087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21.66-165.49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6.75-987.71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11.6-100.92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37.47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L-2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61.14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300.45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33.78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0.31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398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2117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13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9009">
                <a:tc>
                  <a:txBody>
                    <a:bodyPr/>
                    <a:lstStyle/>
                    <a:p>
                      <a:pPr algn="l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237.04-2573.13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46.42-36615.08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7.27-1894.57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195.13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L-8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7.67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.18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4.56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.17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00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125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754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15.43-81.20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3.64-73.30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2.69-910.41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1.35-7.22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FNa2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α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31.37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33.98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86.3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2.1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001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014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005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9009">
                <a:tc>
                  <a:txBody>
                    <a:bodyPr/>
                    <a:lstStyle/>
                    <a:p>
                      <a:pPr algn="l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121.89-326.80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816.152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22.44-1117.89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168.16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-CSF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13.8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7.84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7.05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7.78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464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195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032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9009">
                <a:tc>
                  <a:txBody>
                    <a:bodyPr/>
                    <a:lstStyle/>
                    <a:p>
                      <a:pPr algn="l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22.67-1280.20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29.21-268.66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29.63-115.87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11.16-83.37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IP-1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α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52.49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8.16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0.97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8.71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001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008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061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56.18-297.64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290.21) 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451.27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18.43-43.31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P-10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661.22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763.68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930.74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52.66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13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1139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38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9009">
                <a:tc>
                  <a:txBody>
                    <a:bodyPr/>
                    <a:lstStyle/>
                    <a:p>
                      <a:pPr algn="l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448.08-4863.69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227.60-13355.45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456.19-10000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128.80-648.82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900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kern="1200" spc="-70" baseline="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Fract</a:t>
                      </a:r>
                      <a:r>
                        <a:rPr lang="en-US" altLang="zh-CN" sz="900" b="1" i="0" u="none" strike="noStrike" kern="1200" spc="-70" baseline="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</a:t>
                      </a:r>
                      <a:r>
                        <a:rPr lang="en-US" sz="900" b="1" i="0" u="none" strike="noStrike" kern="1200" spc="-70" baseline="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kine</a:t>
                      </a:r>
                      <a:endParaRPr lang="en-US" sz="900" b="1" i="0" u="none" strike="noStrike" kern="1200" spc="-70" baseline="0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78.38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84.72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69.27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7.85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549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1048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696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427.36) 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3.2-2295.24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53.54-979.48) 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631.80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L-6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5.04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5.94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1.62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.61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026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125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16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7.74-59.89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1.54-453.77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1.96-53.73) 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1.21-18.61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FN-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γ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.14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9.71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8.95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2.45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—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89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607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N.D-6.14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82.01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82.07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9.36-73.97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Eotaxin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6.95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91.51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2.94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58.8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4334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5632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4127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54.90-273.71) 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47.27-767.26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23.47-1034.97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33.34-334.12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L-12P40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42.25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35.21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05.15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30.69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068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55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5411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513.26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537.09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1085.68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778.05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Fit-3L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8.98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4.81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92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4.6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8317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907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507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3.2-106.22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128.25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149.68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&lt;3.2-129.24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CP-1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55.84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79.34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93.55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04.45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187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823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8011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9009"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156.89-535.22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79.45-329.01) 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44.16-455.35) 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101.66-388.92)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4689" marR="4689" marT="46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Blank Presentation">
  <a:themeElements>
    <a:clrScheme name="Blank Presentatio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Blank Presentation">
      <a:majorFont>
        <a:latin typeface="Times"/>
        <a:ea typeface=""/>
        <a:cs typeface=""/>
      </a:majorFont>
      <a:minorFont>
        <a:latin typeface="Times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 pitchFamily="18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 pitchFamily="18" charset="0"/>
          </a:defRPr>
        </a:defPPr>
      </a:lstStyle>
    </a:lnDef>
  </a:objectDefaults>
  <a:extraClrSchemeLst>
    <a:extraClrScheme>
      <a:clrScheme name="Blank Presentatio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主题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主题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Studio</Template>
  <TotalTime>405153976</TotalTime>
  <Words>402</Words>
  <Application>Microsoft Office PowerPoint</Application>
  <PresentationFormat>自定义</PresentationFormat>
  <Paragraphs>22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Blank Presentation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o Slide Title</dc:title>
  <dc:creator>dell</dc:creator>
  <cp:lastModifiedBy>dell</cp:lastModifiedBy>
  <cp:revision>1190</cp:revision>
  <cp:lastPrinted>2003-03-14T12:15:20Z</cp:lastPrinted>
  <dcterms:modified xsi:type="dcterms:W3CDTF">2013-05-09T03:08:07Z</dcterms:modified>
</cp:coreProperties>
</file>